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  <p:sldId id="260" r:id="rId5"/>
    <p:sldId id="261" r:id="rId6"/>
    <p:sldId id="262" r:id="rId7"/>
    <p:sldId id="263" r:id="rId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2439" y="5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33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804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16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54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329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400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350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84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19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253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571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D070F-1FC6-48C5-9DB9-7C033CB7889E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596B4-75BB-424C-93C9-92A9A8CD9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264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ry Dat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1200" dirty="0" err="1"/>
              <a:t>Granulosa</a:t>
            </a:r>
            <a:r>
              <a:rPr lang="en-US" sz="1200" dirty="0"/>
              <a:t> cell-derived miR-379-5p shifts macrophage polarization to M1: An inflammatory mechanism in polycystic ovaries</a:t>
            </a:r>
          </a:p>
          <a:p>
            <a:pPr marL="0" indent="0">
              <a:buNone/>
            </a:pPr>
            <a:endParaRPr lang="en-US" sz="1200" dirty="0" smtClean="0"/>
          </a:p>
          <a:p>
            <a:pPr marL="0" indent="0">
              <a:buNone/>
            </a:pPr>
            <a:r>
              <a:rPr lang="en-US" sz="1200" dirty="0" smtClean="0"/>
              <a:t>Reza </a:t>
            </a:r>
            <a:r>
              <a:rPr lang="en-US" sz="1200" dirty="0"/>
              <a:t>Salehi1,4,6, Meshach Asare-Werehene1,4, Brandon A. Wyse6, </a:t>
            </a:r>
            <a:r>
              <a:rPr lang="en-US" sz="1200" dirty="0" err="1"/>
              <a:t>Atefeh</a:t>
            </a:r>
            <a:r>
              <a:rPr lang="en-US" sz="1200" dirty="0"/>
              <a:t> Abedini2, Bo Pan3, Alex Gutsol5, </a:t>
            </a:r>
            <a:r>
              <a:rPr lang="en-US" sz="1200" dirty="0" err="1"/>
              <a:t>Sahar</a:t>
            </a:r>
            <a:r>
              <a:rPr lang="en-US" sz="1200" dirty="0"/>
              <a:t> Jahangiri6, Peter Szaraz6, Kevin D. Burns5, Barbara Vanderhyden2,4, </a:t>
            </a:r>
            <a:r>
              <a:rPr lang="en-US" sz="1200" dirty="0" err="1"/>
              <a:t>Julang</a:t>
            </a:r>
            <a:r>
              <a:rPr lang="en-US" sz="1200" dirty="0"/>
              <a:t> Li3, Dylan Burger1,5, Clifford L. Librach6,7,8,9 and Benjamin K. Tsang1,4 </a:t>
            </a:r>
          </a:p>
          <a:p>
            <a:endParaRPr lang="en-US" sz="1200" dirty="0"/>
          </a:p>
          <a:p>
            <a:endParaRPr lang="en-US" sz="1200" dirty="0"/>
          </a:p>
          <a:p>
            <a:pPr marL="0" indent="0">
              <a:buNone/>
            </a:pPr>
            <a:r>
              <a:rPr lang="en-US" sz="1200" dirty="0"/>
              <a:t>1Chronic Disease Program and 2Cancer Therapeutics Program, Ottawa Hospital Research Institute, Ottawa, Ontario, Canada; </a:t>
            </a:r>
          </a:p>
          <a:p>
            <a:pPr marL="0" indent="0">
              <a:buNone/>
            </a:pPr>
            <a:r>
              <a:rPr lang="en-US" sz="1200" dirty="0"/>
              <a:t>3Department of Animal </a:t>
            </a:r>
            <a:r>
              <a:rPr lang="en-US" sz="1200" dirty="0" err="1"/>
              <a:t>BioScience</a:t>
            </a:r>
            <a:r>
              <a:rPr lang="en-US" sz="1200" dirty="0"/>
              <a:t>, University of Guelph, Guelph, Ontario, Canada; </a:t>
            </a:r>
          </a:p>
          <a:p>
            <a:pPr marL="0" indent="0">
              <a:buNone/>
            </a:pPr>
            <a:r>
              <a:rPr lang="en-US" sz="1200" dirty="0"/>
              <a:t>4Departments of Obstetrics and Gynecology &amp; Cellular and Molecular Medicine, and 5Division of Nephrology, Department of Medicine, Kidney Research Centre and the Center for Infection, Immunity and Inflammation, University of Ottawa, Ottawa, Ontario, Canada;</a:t>
            </a:r>
          </a:p>
          <a:p>
            <a:pPr marL="0" indent="0">
              <a:buNone/>
            </a:pPr>
            <a:r>
              <a:rPr lang="en-US" sz="1200" dirty="0"/>
              <a:t>6CReATe Fertility Centre, Toronto, Ontario, Canada; </a:t>
            </a:r>
          </a:p>
          <a:p>
            <a:pPr marL="0" indent="0">
              <a:buNone/>
            </a:pPr>
            <a:r>
              <a:rPr lang="en-US" sz="1200" dirty="0"/>
              <a:t>7Departments of Obstetrics &amp; </a:t>
            </a:r>
            <a:r>
              <a:rPr lang="en-US" sz="1200" dirty="0" err="1"/>
              <a:t>Gynaecology</a:t>
            </a:r>
            <a:r>
              <a:rPr lang="en-US" sz="1200" dirty="0"/>
              <a:t>, 8Physiology, and 9Institute of Medical Sciences, University of Toronto, Toronto, Ontario, Canada. </a:t>
            </a:r>
          </a:p>
          <a:p>
            <a:endParaRPr lang="en-US" sz="1200" dirty="0"/>
          </a:p>
          <a:p>
            <a:pPr marL="0" indent="0">
              <a:buNone/>
            </a:pPr>
            <a:r>
              <a:rPr lang="en-US" sz="1200" dirty="0"/>
              <a:t>Conflict of interest: The authors declare no conflict of interest.</a:t>
            </a:r>
          </a:p>
          <a:p>
            <a:pPr marL="0" indent="0">
              <a:buNone/>
            </a:pPr>
            <a:r>
              <a:rPr lang="en-US" sz="1200" dirty="0"/>
              <a:t>*Correspondence: Benjamin K. Tsang, PhD, Chronic Disease Program, Ottawa Hospital Research Institute, The Ottawa Hospital – General Campus; Critical Care Wing - 3rd Floor, Room W3107, 501 Smyth Road, Mail Box #511, Ottawa, Ontario K1H 8L6</a:t>
            </a:r>
          </a:p>
          <a:p>
            <a:pPr marL="0" indent="0">
              <a:buNone/>
            </a:pPr>
            <a:r>
              <a:rPr lang="en-US" sz="1200" dirty="0"/>
              <a:t>Tel: 1-613-798-5555, Ext. 72926</a:t>
            </a:r>
          </a:p>
          <a:p>
            <a:pPr marL="0" indent="0">
              <a:buNone/>
            </a:pPr>
            <a:r>
              <a:rPr lang="en-US" sz="1200" dirty="0"/>
              <a:t>Fax: 1-613-739-6968</a:t>
            </a:r>
          </a:p>
          <a:p>
            <a:pPr marL="0" indent="0">
              <a:buNone/>
            </a:pPr>
            <a:r>
              <a:rPr lang="en-US" sz="1200" dirty="0"/>
              <a:t>Email: btsang@ohri.ca </a:t>
            </a:r>
          </a:p>
        </p:txBody>
      </p:sp>
    </p:spTree>
    <p:extLst>
      <p:ext uri="{BB962C8B-B14F-4D97-AF65-F5344CB8AC3E}">
        <p14:creationId xmlns:p14="http://schemas.microsoft.com/office/powerpoint/2010/main" val="1911294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1392" y="4038600"/>
            <a:ext cx="651666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nulosa cell-macrophag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-culture.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ulosa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transfected with CD63-GFP (green) and Alexa-647 labelled miR-379-5p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), allowing the tracking of exosome and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379-5p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co-culture system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produce bone marrow derived macrophage, bo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row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isolated fr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 femur and tibi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differentia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macrophages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CSF f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 day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tro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Granulos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isolate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ant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llicles (diethylstilbestrol-primed immature rats; day 21, 1 mg/d, subcutaneously, for 3 consecutive days)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9-5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Va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C10316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mo-Fisher; 18h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were further cultured for 36h. Macrophages were polarized to M1 and M2 by LPS (1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ρ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 + IFN-γ (20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g/mL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L-4 (20ng/mL) treatment for 36h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87037" y="93768"/>
            <a:ext cx="3189563" cy="361413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50" t="3175" r="27361" b="8532"/>
          <a:stretch/>
        </p:blipFill>
        <p:spPr bwMode="auto">
          <a:xfrm>
            <a:off x="101150" y="368759"/>
            <a:ext cx="3162749" cy="3319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95662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107504"/>
            <a:ext cx="3204149" cy="4248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97" t="23818" r="42595" b="63737"/>
          <a:stretch/>
        </p:blipFill>
        <p:spPr bwMode="auto">
          <a:xfrm>
            <a:off x="141061" y="4461892"/>
            <a:ext cx="1204680" cy="936104"/>
          </a:xfrm>
          <a:prstGeom prst="ellipse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Straight Connector 3"/>
          <p:cNvCxnSpPr/>
          <p:nvPr/>
        </p:nvCxnSpPr>
        <p:spPr>
          <a:xfrm flipH="1">
            <a:off x="160113" y="3957836"/>
            <a:ext cx="485004" cy="86409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>
            <a:endCxn id="1035" idx="7"/>
          </p:cNvCxnSpPr>
          <p:nvPr/>
        </p:nvCxnSpPr>
        <p:spPr>
          <a:xfrm>
            <a:off x="789133" y="3957836"/>
            <a:ext cx="380187" cy="64114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V="1">
            <a:off x="937489" y="4668391"/>
            <a:ext cx="648072" cy="1"/>
          </a:xfrm>
          <a:prstGeom prst="straightConnector1">
            <a:avLst/>
          </a:prstGeom>
          <a:ln w="34925">
            <a:solidFill>
              <a:schemeClr val="accent6">
                <a:lumMod val="75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1158698" y="5074830"/>
            <a:ext cx="426863" cy="1"/>
          </a:xfrm>
          <a:prstGeom prst="straightConnector1">
            <a:avLst/>
          </a:prstGeom>
          <a:ln w="34925"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643281" y="4340736"/>
            <a:ext cx="145010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M2 macrophage: </a:t>
            </a:r>
          </a:p>
          <a:p>
            <a:pPr marL="285750" indent="-285750">
              <a:buFontTx/>
              <a:buChar char="-"/>
            </a:pPr>
            <a:r>
              <a:rPr lang="en-US" sz="1200" dirty="0" smtClean="0">
                <a:latin typeface="Arial Narrow" panose="020B0606020202030204" pitchFamily="34" charset="0"/>
              </a:rPr>
              <a:t>CD163: CY3</a:t>
            </a:r>
          </a:p>
          <a:p>
            <a:pPr marL="285750" indent="-285750">
              <a:buFontTx/>
              <a:buChar char="-"/>
            </a:pPr>
            <a:r>
              <a:rPr lang="en-US" sz="1200" dirty="0" smtClean="0">
                <a:latin typeface="Arial Narrow" panose="020B0606020202030204" pitchFamily="34" charset="0"/>
              </a:rPr>
              <a:t>CD68: Alexa 488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643281" y="5017680"/>
            <a:ext cx="145010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M1 macrophage: </a:t>
            </a:r>
          </a:p>
          <a:p>
            <a:pPr marL="285750" indent="-285750">
              <a:buFontTx/>
              <a:buChar char="-"/>
            </a:pPr>
            <a:r>
              <a:rPr lang="en-US" sz="1200" dirty="0" smtClean="0">
                <a:latin typeface="Arial Narrow" panose="020B0606020202030204" pitchFamily="34" charset="0"/>
              </a:rPr>
              <a:t>CD68: Alexa 488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392789" y="107504"/>
            <a:ext cx="327657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histologica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ovaries treated with lentivirus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istological assessment of ovaries treated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 of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treatments, lentivirus-RFP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ntivirus-RFP-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379-5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HT + lentivirus-R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HT + lentivirus-RFP-miR-379-5p. Lentiviru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les (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) were injected under the ovarian bursa.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232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1" y="371977"/>
            <a:ext cx="2232248" cy="2831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2564904" y="257285"/>
            <a:ext cx="4104456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3: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379-5p-induce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 polarizati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d th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F-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ed medium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ion of macrophage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379-5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 increases the levels of TNF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 bone marrow derived macrophage, bone marrow cells were isolated from rat femur and tibia and differentiated to macrophages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CS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7 days in vitro. Macrophages were transfected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-379-5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Va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mics, MC10316, Thermo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sher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inhibitor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Va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or, MH10316; 18h) and cultured for 36h.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88642" y="253415"/>
            <a:ext cx="2304254" cy="295043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22650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4624" y="181134"/>
            <a:ext cx="42484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able S1: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list of antibodies and their dilution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7134077"/>
              </p:ext>
            </p:extLst>
          </p:nvPr>
        </p:nvGraphicFramePr>
        <p:xfrm>
          <a:off x="188640" y="488072"/>
          <a:ext cx="6561900" cy="3291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283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64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083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861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924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3681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ntibody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ecies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t #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mpany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lution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163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 and 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b18242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bcam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0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86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09-13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68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14-651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206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00-23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LA-DR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11-94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alectin 3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12-969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:1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sotype Control Antibody, rat IgG2a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0-102-65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ltenyi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otec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PDK1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 and huma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306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ell Signaling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:100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CM2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 and huma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3619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ell Signaling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:100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nti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i67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 and huma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b16667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bcam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:1000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6815">
                <a:tc>
                  <a:txBody>
                    <a:bodyPr/>
                    <a:lstStyle/>
                    <a:p>
                      <a:pPr algn="l"/>
                      <a:r>
                        <a:rPr lang="en-US" sz="12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APDH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t and huma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b181602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bcam</a:t>
                      </a:r>
                      <a:endParaRPr lang="en-US" sz="120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:10,000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5106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4619" y="179512"/>
            <a:ext cx="63407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 of subject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ted in cytokine assessment (follicular fluid), and macrophage population and polarization assessm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ean ± SEM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4237055"/>
              </p:ext>
            </p:extLst>
          </p:nvPr>
        </p:nvGraphicFramePr>
        <p:xfrm>
          <a:off x="261753" y="652329"/>
          <a:ext cx="5758048" cy="415369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7054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427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574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246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8288">
                <a:tc>
                  <a:txBody>
                    <a:bodyPr/>
                    <a:lstStyle/>
                    <a:p>
                      <a:pPr fontAlgn="t"/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PCO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O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663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</a:t>
                      </a:r>
                      <a:r>
                        <a:rPr lang="en-US" sz="12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luids, n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663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kg/m</a:t>
                      </a:r>
                      <a:r>
                        <a:rPr lang="en-US" sz="120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0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± 0.7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6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± 0.7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MH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71 ± 8.1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.71 ± 8.1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= 0.000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2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46.69 ± 24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78.56 ± 24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H (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U/m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 ± 0.7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 ± 0.7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ectin-1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99.03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438.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28.21 ± 438.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ectin-3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.79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1.3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.30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1.3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&lt; 0.000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tatin C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46.52 ± 627.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55.31 ± 627.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9216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5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26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26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marL="0" indent="0" algn="r" rtl="1" fontAlgn="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None/>
                      </a:pP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teoprotegerin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6.30 ± 271.3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5.36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71.3</a:t>
                      </a:r>
                      <a:endParaRPr lang="en-US" sz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663" marR="53663" marT="35775" marB="3577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ells, n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BMI (kg/m</a:t>
                      </a:r>
                      <a:r>
                        <a:rPr lang="en-US" sz="120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.77 ± 0.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3</a:t>
                      </a:r>
                      <a:endParaRPr lang="en-US" sz="120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.35 ± 0.9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MH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.11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07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3.31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07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&lt;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2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369 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±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948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870 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±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948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828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H (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U/m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40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4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31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4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1485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9543125"/>
              </p:ext>
            </p:extLst>
          </p:nvPr>
        </p:nvGraphicFramePr>
        <p:xfrm>
          <a:off x="152400" y="451170"/>
          <a:ext cx="3352800" cy="119767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6700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857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5131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icular cells, n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= 39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131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 (kg/m</a:t>
                      </a:r>
                      <a:r>
                        <a:rPr lang="en-US" sz="120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02 ± 2.9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131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MH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56 ± 7.7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1318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2 (</a:t>
                      </a:r>
                      <a:r>
                        <a:rPr lang="en-US" sz="120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mol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70.31 ± 27167.6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1533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H (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U/m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 ± 1.5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4222" y="152400"/>
            <a:ext cx="6270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aracteristics of non-PCOS subjects used for cell cultu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n ± S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835918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6</TotalTime>
  <Words>891</Words>
  <Application>Microsoft Office PowerPoint</Application>
  <PresentationFormat>On-screen Show (4:3)</PresentationFormat>
  <Paragraphs>15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Narrow</vt:lpstr>
      <vt:lpstr>Calibri</vt:lpstr>
      <vt:lpstr>Times New Roman</vt:lpstr>
      <vt:lpstr>Office Theme</vt:lpstr>
      <vt:lpstr>Supplementary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Ottawa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Asare-Werehene, Meshach</dc:creator>
  <cp:lastModifiedBy>Salehi Karashk, Reza (HC/SC)</cp:lastModifiedBy>
  <cp:revision>16</cp:revision>
  <cp:lastPrinted>2023-02-06T00:16:06Z</cp:lastPrinted>
  <dcterms:created xsi:type="dcterms:W3CDTF">2022-07-26T19:29:43Z</dcterms:created>
  <dcterms:modified xsi:type="dcterms:W3CDTF">2023-02-17T14:48:38Z</dcterms:modified>
</cp:coreProperties>
</file>